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Roxana Gheorghe" initials="R" lastIdx="1" clrIdx="0">
    <p:extLst>
      <p:ext uri="{19B8F6BF-5375-455C-9EA6-DF929625EA0E}">
        <p15:presenceInfo xmlns:p15="http://schemas.microsoft.com/office/powerpoint/2012/main" userId="Roxana Gheorgh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2" d="100"/>
          <a:sy n="82" d="100"/>
        </p:scale>
        <p:origin x="691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D0AF15-C3D3-26CA-3199-678047BF7E3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D2B79C7-C627-66E8-6AE9-3E4F8987587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EBA5C4-742A-42C7-3EEE-A0ABF3D47C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2F0FC-76AC-4E2C-8864-23E11B1077C5}" type="datetimeFigureOut">
              <a:rPr lang="en-US" smtClean="0"/>
              <a:t>10/3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B272BF-D5B6-A851-C0BD-0DC1C04265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80D0DB-2DF7-3CC9-A83B-9DB4BAC274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0D8B3-6186-4A61-95E8-3B1D5F837A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38642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435D0D-C489-B3E7-A117-B7819A850D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3C9A829-5552-EA58-C25E-5C13DF0E22F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29D16E-5C7E-4688-E07E-A7535BE51D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2F0FC-76AC-4E2C-8864-23E11B1077C5}" type="datetimeFigureOut">
              <a:rPr lang="en-US" smtClean="0"/>
              <a:t>10/3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265160-CB0D-0B60-8F82-AA276E62E0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F29882-579B-C15F-E4D3-A02BCC64DB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0D8B3-6186-4A61-95E8-3B1D5F837A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84023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50BD835-D79E-50FB-C518-7A1AE7CB385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D5A6D5D-232F-EB61-4CA5-E336E414CE8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3BB4BA-569E-4AA0-C898-572FBB79AE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2F0FC-76AC-4E2C-8864-23E11B1077C5}" type="datetimeFigureOut">
              <a:rPr lang="en-US" smtClean="0"/>
              <a:t>10/3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0FD2BE-6B92-8D8F-FFCE-2AB9441703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D9742B-77FD-F336-1852-0E1A76D72A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0D8B3-6186-4A61-95E8-3B1D5F837A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5552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7A9E67-3C4F-DD04-D38B-4389FE895A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4360FEC-2C0F-E86F-7940-BDCF83B5CEA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74249E-803B-BA80-2459-ED52380A52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2F0FC-76AC-4E2C-8864-23E11B1077C5}" type="datetimeFigureOut">
              <a:rPr lang="en-US" smtClean="0"/>
              <a:t>10/3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B97B5D-5DA4-9534-B413-6C9007451D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6B5452-6B6A-DBA0-EBEC-28DC5D6B62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0D8B3-6186-4A61-95E8-3B1D5F837A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86300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3AC89D-7D5E-5D2C-CDCC-3A7E6C92D3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CDABE87-E819-65DA-87A4-EE3F612F73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D0E20D-1E8D-F887-8793-C7D93DB527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2F0FC-76AC-4E2C-8864-23E11B1077C5}" type="datetimeFigureOut">
              <a:rPr lang="en-US" smtClean="0"/>
              <a:t>10/3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297E1B-2688-5C68-CB8A-F41AFD9E72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8CB7D7-8EBD-F0EF-30BB-4D4BD11CD0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0D8B3-6186-4A61-95E8-3B1D5F837A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89147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283C55-952A-606C-3A1C-347850A160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62D1352-A966-1270-8D46-1B015005BF5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CA518C2-7DFB-8769-48D6-60A807DB02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028E3E6-D549-E254-CDB5-D08607BBC5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2F0FC-76AC-4E2C-8864-23E11B1077C5}" type="datetimeFigureOut">
              <a:rPr lang="en-US" smtClean="0"/>
              <a:t>10/3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E829CF9-0288-E4EF-EE23-9211C17958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F303A93-226A-F2BE-7CC1-1553B9902D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0D8B3-6186-4A61-95E8-3B1D5F837A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59798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F8C9A6-7A71-0896-0278-3FC8D117B3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65734E1-B9CA-D936-7B25-747E333CB3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9EE3899-E70C-3479-4E66-18CB1EEC16E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BCF7ABF-02A2-173F-0D0D-DEDE8BEAB79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07F1F02-A524-895F-F0BD-FEBFB23C562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E4E1CDA-A366-DF11-7CCC-0E776174F9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2F0FC-76AC-4E2C-8864-23E11B1077C5}" type="datetimeFigureOut">
              <a:rPr lang="en-US" smtClean="0"/>
              <a:t>10/31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661E1CD-1A1B-9DC0-223F-202143B35E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753FB53-AEC1-EF6F-ABDC-A01AB1FB8F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0D8B3-6186-4A61-95E8-3B1D5F837A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00798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64A667-FEC0-A43E-2997-E816338554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1DC5E73-6635-CA90-BC62-868B102624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2F0FC-76AC-4E2C-8864-23E11B1077C5}" type="datetimeFigureOut">
              <a:rPr lang="en-US" smtClean="0"/>
              <a:t>10/31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7A3A6EE-ED82-3E82-6885-42C7D525BE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5887FA0-E235-1961-F4E0-F6A3290B6A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0D8B3-6186-4A61-95E8-3B1D5F837A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56630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6B1F35B-DF02-FB3B-BCA7-36B10B814A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2F0FC-76AC-4E2C-8864-23E11B1077C5}" type="datetimeFigureOut">
              <a:rPr lang="en-US" smtClean="0"/>
              <a:t>10/31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D9999DD-6C0C-29C1-E3EE-9376CEDF88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6176B43-D51C-CA16-9673-9A47B757F8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0D8B3-6186-4A61-95E8-3B1D5F837A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12242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0CC606-FAEA-8303-F176-2C3D28929D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AC1715C-7A44-27B7-768D-C87C8D79059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3F759CD-E1AC-4441-AD04-FABA556AA81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273D1F-2764-E953-BB45-1643933DD9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2F0FC-76AC-4E2C-8864-23E11B1077C5}" type="datetimeFigureOut">
              <a:rPr lang="en-US" smtClean="0"/>
              <a:t>10/3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DE37A08-DEE5-155C-A0F2-CD928E733E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58E41E3-E267-2AA5-70A6-FD954CB24D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0D8B3-6186-4A61-95E8-3B1D5F837A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86570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323BB8-F3CB-55CF-EE4D-5AA2334FE3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43BE18D-75E6-A04C-E892-06526890BC7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6E87415-5D16-87BE-997B-2130FCE4DC2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2F7C4B9-DBB3-A148-8E09-4C8AA0193E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2F0FC-76AC-4E2C-8864-23E11B1077C5}" type="datetimeFigureOut">
              <a:rPr lang="en-US" smtClean="0"/>
              <a:t>10/3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0D23BB4-4300-1926-E8FF-897DEACC92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CA0C6A6-AC1F-A28A-A11E-A756AF4E22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0D8B3-6186-4A61-95E8-3B1D5F837A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77700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2083A61-07C7-740B-737C-E604A1B686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C3D824E-C1B4-DDFB-3A87-D63CEF5EE8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79C0B9-A4C2-1B1F-3F1A-22F91B8797E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62F0FC-76AC-4E2C-8864-23E11B1077C5}" type="datetimeFigureOut">
              <a:rPr lang="en-US" smtClean="0"/>
              <a:t>10/3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6C1A82-768F-0401-3578-DCDA89AD456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77ED76-CD5F-9FF6-76F5-DCC695E0F23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80D8B3-6186-4A61-95E8-3B1D5F837A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45640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e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35073" y="57150"/>
            <a:ext cx="9004198" cy="6800850"/>
            <a:chOff x="1497291" y="28576"/>
            <a:chExt cx="9004198" cy="6800850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4ECF7AC0-4F0D-A72F-D59D-333103A380C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97291" y="28577"/>
              <a:ext cx="4424313" cy="3370905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6A13B193-C832-A1CB-2980-A110E933670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97291" y="3429001"/>
              <a:ext cx="4424314" cy="3370906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02E38B5F-81EE-6098-7FC3-C0F64F5097F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10274" y="28576"/>
              <a:ext cx="4424313" cy="3370905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DC23D4A0-7EB2-B384-01AC-A8DF95E6615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10274" y="3429000"/>
              <a:ext cx="4424315" cy="3370907"/>
            </a:xfrm>
            <a:prstGeom prst="rect">
              <a:avLst/>
            </a:prstGeom>
          </p:spPr>
        </p:pic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F4D3D59A-BEE6-DDE0-43B3-0247CF41930A}"/>
                </a:ext>
              </a:extLst>
            </p:cNvPr>
            <p:cNvCxnSpPr>
              <a:cxnSpLocks/>
            </p:cNvCxnSpPr>
            <p:nvPr/>
          </p:nvCxnSpPr>
          <p:spPr>
            <a:xfrm>
              <a:off x="1616575" y="3237563"/>
              <a:ext cx="320987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08C0ED92-8386-EA2E-5C92-5CB4F6348DDA}"/>
                </a:ext>
              </a:extLst>
            </p:cNvPr>
            <p:cNvSpPr txBox="1"/>
            <p:nvPr/>
          </p:nvSpPr>
          <p:spPr>
            <a:xfrm>
              <a:off x="9661702" y="3060927"/>
              <a:ext cx="77288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solidFill>
                    <a:schemeClr val="bg1"/>
                  </a:solidFill>
                </a:rPr>
                <a:t>Sham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AF10DD3C-B6A7-1831-F3A0-BE127C6C8DC3}"/>
                </a:ext>
              </a:extLst>
            </p:cNvPr>
            <p:cNvSpPr txBox="1"/>
            <p:nvPr/>
          </p:nvSpPr>
          <p:spPr>
            <a:xfrm>
              <a:off x="4641670" y="3060927"/>
              <a:ext cx="128600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solidFill>
                    <a:schemeClr val="bg1"/>
                  </a:solidFill>
                </a:rPr>
                <a:t>Non-treated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4C25F39C-2AC0-9B1E-928D-6BFF01F7A74A}"/>
                </a:ext>
              </a:extLst>
            </p:cNvPr>
            <p:cNvSpPr txBox="1"/>
            <p:nvPr/>
          </p:nvSpPr>
          <p:spPr>
            <a:xfrm>
              <a:off x="8910590" y="6490872"/>
              <a:ext cx="159089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solidFill>
                    <a:schemeClr val="bg1"/>
                  </a:solidFill>
                </a:rPr>
                <a:t>SNL+Iba1-siRNA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00392AC6-1F24-4182-3898-CD23A88E8C6B}"/>
                </a:ext>
              </a:extLst>
            </p:cNvPr>
            <p:cNvSpPr txBox="1"/>
            <p:nvPr/>
          </p:nvSpPr>
          <p:spPr>
            <a:xfrm>
              <a:off x="5313589" y="6451975"/>
              <a:ext cx="77288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solidFill>
                    <a:schemeClr val="bg1"/>
                  </a:solidFill>
                </a:rPr>
                <a:t>SNL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78016F02-45D8-C88E-AC48-14EC43CB04CC}"/>
                </a:ext>
              </a:extLst>
            </p:cNvPr>
            <p:cNvSpPr txBox="1"/>
            <p:nvPr/>
          </p:nvSpPr>
          <p:spPr>
            <a:xfrm>
              <a:off x="4397604" y="94538"/>
              <a:ext cx="154577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solidFill>
                    <a:srgbClr val="00FF00"/>
                  </a:solidFill>
                </a:rPr>
                <a:t>Iba1</a:t>
              </a:r>
              <a:r>
                <a:rPr lang="en-US" sz="1600" dirty="0">
                  <a:solidFill>
                    <a:schemeClr val="bg1"/>
                  </a:solidFill>
                </a:rPr>
                <a:t>/</a:t>
              </a:r>
              <a:r>
                <a:rPr lang="en-US" sz="1600" b="1" dirty="0">
                  <a:solidFill>
                    <a:srgbClr val="FF0000"/>
                  </a:solidFill>
                </a:rPr>
                <a:t>ED1</a:t>
              </a:r>
              <a:r>
                <a:rPr lang="en-US" sz="1600" dirty="0">
                  <a:solidFill>
                    <a:schemeClr val="bg1"/>
                  </a:solidFill>
                </a:rPr>
                <a:t>/</a:t>
              </a:r>
              <a:r>
                <a:rPr lang="en-US" sz="1600" b="1" dirty="0">
                  <a:solidFill>
                    <a:srgbClr val="0070C0"/>
                  </a:solidFill>
                </a:rPr>
                <a:t>DAPI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195A0501-4C44-22A9-5007-47D634D52FBA}"/>
                </a:ext>
              </a:extLst>
            </p:cNvPr>
            <p:cNvSpPr txBox="1"/>
            <p:nvPr/>
          </p:nvSpPr>
          <p:spPr>
            <a:xfrm>
              <a:off x="8843688" y="94538"/>
              <a:ext cx="154577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solidFill>
                    <a:srgbClr val="00FF00"/>
                  </a:solidFill>
                </a:rPr>
                <a:t>Iba1</a:t>
              </a:r>
              <a:r>
                <a:rPr lang="en-US" sz="1600" dirty="0">
                  <a:solidFill>
                    <a:schemeClr val="bg1"/>
                  </a:solidFill>
                </a:rPr>
                <a:t>/</a:t>
              </a:r>
              <a:r>
                <a:rPr lang="en-US" sz="1600" b="1" dirty="0">
                  <a:solidFill>
                    <a:srgbClr val="FF0000"/>
                  </a:solidFill>
                </a:rPr>
                <a:t>ED1</a:t>
              </a:r>
              <a:r>
                <a:rPr lang="en-US" sz="1600" dirty="0">
                  <a:solidFill>
                    <a:schemeClr val="bg1"/>
                  </a:solidFill>
                </a:rPr>
                <a:t>/</a:t>
              </a:r>
              <a:r>
                <a:rPr lang="en-US" sz="1600" b="1" dirty="0">
                  <a:solidFill>
                    <a:srgbClr val="0070C0"/>
                  </a:solidFill>
                </a:rPr>
                <a:t>DAPI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B8CA27D1-9434-9CC8-9AAB-93546C4D3A8D}"/>
                </a:ext>
              </a:extLst>
            </p:cNvPr>
            <p:cNvSpPr txBox="1"/>
            <p:nvPr/>
          </p:nvSpPr>
          <p:spPr>
            <a:xfrm>
              <a:off x="4397603" y="3485585"/>
              <a:ext cx="154577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solidFill>
                    <a:srgbClr val="00FF00"/>
                  </a:solidFill>
                </a:rPr>
                <a:t>Iba1</a:t>
              </a:r>
              <a:r>
                <a:rPr lang="en-US" sz="1600" dirty="0">
                  <a:solidFill>
                    <a:schemeClr val="bg1"/>
                  </a:solidFill>
                </a:rPr>
                <a:t>/</a:t>
              </a:r>
              <a:r>
                <a:rPr lang="en-US" sz="1600" b="1" dirty="0">
                  <a:solidFill>
                    <a:srgbClr val="FF0000"/>
                  </a:solidFill>
                </a:rPr>
                <a:t>ED1</a:t>
              </a:r>
              <a:r>
                <a:rPr lang="en-US" sz="1600" dirty="0">
                  <a:solidFill>
                    <a:schemeClr val="bg1"/>
                  </a:solidFill>
                </a:rPr>
                <a:t>/</a:t>
              </a:r>
              <a:r>
                <a:rPr lang="en-US" sz="1600" b="1" dirty="0">
                  <a:solidFill>
                    <a:srgbClr val="0070C0"/>
                  </a:solidFill>
                </a:rPr>
                <a:t>DAPI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6CE215E0-AEA9-E10C-00C9-0BE184DF6D65}"/>
                </a:ext>
              </a:extLst>
            </p:cNvPr>
            <p:cNvSpPr txBox="1"/>
            <p:nvPr/>
          </p:nvSpPr>
          <p:spPr>
            <a:xfrm>
              <a:off x="8843688" y="3485585"/>
              <a:ext cx="154577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solidFill>
                    <a:srgbClr val="00FF00"/>
                  </a:solidFill>
                </a:rPr>
                <a:t>Iba1</a:t>
              </a:r>
              <a:r>
                <a:rPr lang="en-US" sz="1600" dirty="0">
                  <a:solidFill>
                    <a:schemeClr val="bg1"/>
                  </a:solidFill>
                </a:rPr>
                <a:t>/</a:t>
              </a:r>
              <a:r>
                <a:rPr lang="en-US" sz="1600" b="1" dirty="0">
                  <a:solidFill>
                    <a:srgbClr val="FF0000"/>
                  </a:solidFill>
                </a:rPr>
                <a:t>ED1</a:t>
              </a:r>
              <a:r>
                <a:rPr lang="en-US" sz="1600" dirty="0">
                  <a:solidFill>
                    <a:schemeClr val="bg1"/>
                  </a:solidFill>
                </a:rPr>
                <a:t>/</a:t>
              </a:r>
              <a:r>
                <a:rPr lang="en-US" sz="1600" b="1" dirty="0">
                  <a:solidFill>
                    <a:srgbClr val="0070C0"/>
                  </a:solidFill>
                </a:rPr>
                <a:t>DAPI</a:t>
              </a:r>
            </a:p>
          </p:txBody>
        </p: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8ACB7FB6-9E3A-B7DC-0045-95DED9E43408}"/>
              </a:ext>
            </a:extLst>
          </p:cNvPr>
          <p:cNvSpPr txBox="1"/>
          <p:nvPr/>
        </p:nvSpPr>
        <p:spPr>
          <a:xfrm>
            <a:off x="9338155" y="57150"/>
            <a:ext cx="2618772" cy="41102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indent="0" algn="just">
              <a:lnSpc>
                <a:spcPct val="11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en-US" sz="1200" b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7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Macrophages isolated by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mmunopanning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rom L5 DRG after 5 days in different experimental conditions are mainly Iba1 (+) macrophages. Double immunostaining for Iba1 and ED1 for L5 DRG macrophages isolated by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mmunopanning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different experimental conditions, indicates that most of the cells were Iba1 (+). The results confirm that at 5 days after SNL and SNL+Iba1-siRNA most of the L5 DRG macrophages are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sident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with very few infiltrated hematogenous ED1 (+) macrophages, despite the positive selection with CD11b which is expressed by both types of cells. Scale bar: 50 mm.</a:t>
            </a:r>
          </a:p>
        </p:txBody>
      </p:sp>
    </p:spTree>
    <p:extLst>
      <p:ext uri="{BB962C8B-B14F-4D97-AF65-F5344CB8AC3E}">
        <p14:creationId xmlns:p14="http://schemas.microsoft.com/office/powerpoint/2010/main" val="6006557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0</TotalTime>
  <Words>129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xana Gheorghe</dc:creator>
  <cp:lastModifiedBy>MDPI</cp:lastModifiedBy>
  <cp:revision>12</cp:revision>
  <dcterms:created xsi:type="dcterms:W3CDTF">2022-12-01T17:45:53Z</dcterms:created>
  <dcterms:modified xsi:type="dcterms:W3CDTF">2023-10-31T07:29:57Z</dcterms:modified>
</cp:coreProperties>
</file>